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B54C6-9E9A-4CD4-9552-E442681050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824B7-FD2F-4517-8399-3A3C71318E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F5BBA6-813E-4EBC-928F-32185A630D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9F7DE-13E2-4CC8-86C7-7B7FE28828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C4E616-2629-401A-A3D6-F6AC6BD01B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05E5D-C227-4CCA-B931-F6297D57C2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DC68E-D108-407C-9921-E680DCE7CE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5606C-75AD-46CF-B496-4DCEE39D1B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616E86-27E8-4B0C-B05C-05F0F1B383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888BEC-09B4-42FF-8FD3-F724C7CDA7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2661D5-678D-478C-9497-5407031785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A1B98-C61F-4293-9F0B-97F0DFE219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FE521C-3E06-4860-88A7-76974253D3F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6000" y="216000"/>
          <a:ext cx="6337080" cy="6278400"/>
        </p:xfrm>
        <a:graphic>
          <a:graphicData uri="http://schemas.openxmlformats.org/drawingml/2006/table">
            <a:tbl>
              <a:tblPr/>
              <a:tblGrid>
                <a:gridCol w="610920"/>
                <a:gridCol w="245880"/>
                <a:gridCol w="627120"/>
                <a:gridCol w="308160"/>
                <a:gridCol w="441000"/>
                <a:gridCol w="520920"/>
                <a:gridCol w="520560"/>
                <a:gridCol w="627120"/>
                <a:gridCol w="308160"/>
                <a:gridCol w="498240"/>
                <a:gridCol w="554040"/>
                <a:gridCol w="522360"/>
                <a:gridCol w="552600"/>
              </a:tblGrid>
              <a:tr h="18108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dCV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5"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dCVF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ganis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r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ra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dicted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xon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r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ra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dicted exon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r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ersio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640"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musculu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0337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0334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2026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2032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ug. 20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0300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0294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2062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2067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0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0289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0277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0337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0326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2026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20557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560">
                <a:tc rowSpan="5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. norvegicu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675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671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75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74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5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une 20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487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483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72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68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3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451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449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67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65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413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410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43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41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384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380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29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28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row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domesti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dicted</a:t>
                      </a:r>
                      <a:r>
                        <a:rPr b="0" i="1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affold_</a:t>
                      </a:r>
                      <a:br>
                        <a:rPr sz="700"/>
                      </a:b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9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88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92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affold_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6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505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5085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ct. 20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98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101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704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706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rowSpan="3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. sapien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4327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4323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3795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3802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y 20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4277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4272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415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4156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4195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4202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560"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. troglodyte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417039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4166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3737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3741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v. 20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620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4121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4118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4238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4240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1240"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mulatt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dicted</a:t>
                      </a:r>
                      <a:r>
                        <a:rPr b="0" i="1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0244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0240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9667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9667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an. 20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0166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0163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9668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9668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0163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0161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9671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9672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9672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9677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1240"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. tauru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374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377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w.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affold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73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71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rch 20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67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66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416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419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65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64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62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56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5640">
                <a:tc row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. familiari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3529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3532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 row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y 20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3553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35565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4480">
                <a:tc row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. gallu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38411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38415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37388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37393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b 20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4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38427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38431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37397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37401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9680">
                <a:tc rowSpan="7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X. tropicali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opicalis.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affold_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4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0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7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affold_53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opicali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47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47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7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ug. 20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62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8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47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47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9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8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7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47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44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9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05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05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0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02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01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9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00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00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9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2966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296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9680"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. rerio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11797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11801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8750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8755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une 20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11811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11815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8772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8775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8782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8782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8783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8784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rowSpan="6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. rubripe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dicte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51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49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9580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9577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ug. 20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47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47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9569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9568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45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43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23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21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20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19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15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3113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rowSpan="6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. nigroviridi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895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897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442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445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t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b 20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898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899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449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451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901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903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915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917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9185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919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6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920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922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ae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2435400" y="7261200"/>
            <a:ext cx="1898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57240" tIns="0" bIns="0" anchor="ctr">
            <a:noAutofit/>
          </a:bodyPr>
          <a:p>
            <a:pPr algn="ctr">
              <a:tabLst>
                <a:tab algn="l" pos="0"/>
                <a:tab algn="l" pos="1450800"/>
                <a:tab algn="l" pos="2901960"/>
                <a:tab algn="l" pos="4352760"/>
                <a:tab algn="l" pos="5803920"/>
                <a:tab algn="l" pos="7254720"/>
                <a:tab algn="l" pos="8705880"/>
                <a:tab algn="l" pos="1015668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Supplementary information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08T13:10:06Z</dcterms:created>
  <dc:creator>celine</dc:creator>
  <dc:description/>
  <dc:language>en-US</dc:language>
  <cp:lastModifiedBy>celine</cp:lastModifiedBy>
  <dcterms:modified xsi:type="dcterms:W3CDTF">2007-01-08T13:10:20Z</dcterms:modified>
  <cp:revision>1</cp:revision>
  <dc:subject/>
  <dc:title>Diapositive 1</dc:title>
</cp:coreProperties>
</file>